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2256" y="-3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UPMC\results\MTT\revise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UPMC\results\MTT\revis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2849518810148728E-2"/>
          <c:y val="5.0925925925925923E-2"/>
          <c:w val="0.89659492563429566"/>
          <c:h val="0.83929753572470112"/>
        </c:manualLayout>
      </c:layout>
      <c:lineChart>
        <c:grouping val="standard"/>
        <c:varyColors val="0"/>
        <c:ser>
          <c:idx val="0"/>
          <c:order val="0"/>
          <c:tx>
            <c:strRef>
              <c:f>'overM A549'!$I$5</c:f>
              <c:strCache>
                <c:ptCount val="1"/>
                <c:pt idx="0">
                  <c:v>A549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overM A549'!$J$9:$P$9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25646161827984454</c:v>
                  </c:pt>
                  <c:pt idx="2">
                    <c:v>0.35009343013506716</c:v>
                  </c:pt>
                  <c:pt idx="3">
                    <c:v>0</c:v>
                  </c:pt>
                  <c:pt idx="4">
                    <c:v>0.77427515592057705</c:v>
                  </c:pt>
                  <c:pt idx="5">
                    <c:v>0</c:v>
                  </c:pt>
                  <c:pt idx="6">
                    <c:v>0.65747106209544492</c:v>
                  </c:pt>
                </c:numCache>
              </c:numRef>
            </c:plus>
            <c:minus>
              <c:numRef>
                <c:f>'overM A549'!$J$9:$P$9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25646161827984454</c:v>
                  </c:pt>
                  <c:pt idx="2">
                    <c:v>0.35009343013506716</c:v>
                  </c:pt>
                  <c:pt idx="3">
                    <c:v>0</c:v>
                  </c:pt>
                  <c:pt idx="4">
                    <c:v>0.77427515592057705</c:v>
                  </c:pt>
                  <c:pt idx="5">
                    <c:v>0</c:v>
                  </c:pt>
                  <c:pt idx="6">
                    <c:v>0.65747106209544492</c:v>
                  </c:pt>
                </c:numCache>
              </c:numRef>
            </c:minus>
          </c:errBars>
          <c:cat>
            <c:numRef>
              <c:f>'overM A549'!$J$4:$P$4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4">
                  <c:v>5</c:v>
                </c:pt>
                <c:pt idx="6">
                  <c:v>7</c:v>
                </c:pt>
              </c:numCache>
            </c:numRef>
          </c:cat>
          <c:val>
            <c:numRef>
              <c:f>'overM A549'!$J$5:$P$5</c:f>
              <c:numCache>
                <c:formatCode>General</c:formatCode>
                <c:ptCount val="7"/>
                <c:pt idx="0">
                  <c:v>1</c:v>
                </c:pt>
                <c:pt idx="1">
                  <c:v>1.6509092271166665</c:v>
                </c:pt>
                <c:pt idx="2">
                  <c:v>3.5576715041859797</c:v>
                </c:pt>
                <c:pt idx="4">
                  <c:v>12.136008944803232</c:v>
                </c:pt>
                <c:pt idx="6">
                  <c:v>22.169427048634066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overM A549'!$I$6</c:f>
              <c:strCache>
                <c:ptCount val="1"/>
                <c:pt idx="0">
                  <c:v>A549-HA-C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overM A549'!$J$10:$P$10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19842481545081178</c:v>
                  </c:pt>
                  <c:pt idx="2">
                    <c:v>0.26430058799319545</c:v>
                  </c:pt>
                  <c:pt idx="3">
                    <c:v>0</c:v>
                  </c:pt>
                  <c:pt idx="4">
                    <c:v>0.72097454858365984</c:v>
                  </c:pt>
                  <c:pt idx="5">
                    <c:v>0</c:v>
                  </c:pt>
                  <c:pt idx="6">
                    <c:v>0.88291121766257874</c:v>
                  </c:pt>
                </c:numCache>
              </c:numRef>
            </c:plus>
            <c:minus>
              <c:numRef>
                <c:f>'overM A549'!$J$10:$P$10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19842481545081178</c:v>
                  </c:pt>
                  <c:pt idx="2">
                    <c:v>0.26430058799319545</c:v>
                  </c:pt>
                  <c:pt idx="3">
                    <c:v>0</c:v>
                  </c:pt>
                  <c:pt idx="4">
                    <c:v>0.72097454858365984</c:v>
                  </c:pt>
                  <c:pt idx="5">
                    <c:v>0</c:v>
                  </c:pt>
                  <c:pt idx="6">
                    <c:v>0.88291121766257874</c:v>
                  </c:pt>
                </c:numCache>
              </c:numRef>
            </c:minus>
          </c:errBars>
          <c:cat>
            <c:numRef>
              <c:f>'overM A549'!$J$4:$P$4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4">
                  <c:v>5</c:v>
                </c:pt>
                <c:pt idx="6">
                  <c:v>7</c:v>
                </c:pt>
              </c:numCache>
            </c:numRef>
          </c:cat>
          <c:val>
            <c:numRef>
              <c:f>'overM A549'!$J$6:$P$6</c:f>
              <c:numCache>
                <c:formatCode>General</c:formatCode>
                <c:ptCount val="7"/>
                <c:pt idx="0">
                  <c:v>1</c:v>
                </c:pt>
                <c:pt idx="1">
                  <c:v>1.6190497761890768</c:v>
                </c:pt>
                <c:pt idx="2">
                  <c:v>3.2330560110441198</c:v>
                </c:pt>
                <c:pt idx="4">
                  <c:v>11.638859597665766</c:v>
                </c:pt>
                <c:pt idx="6">
                  <c:v>21.281677102376399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overM A549'!$I$7</c:f>
              <c:strCache>
                <c:ptCount val="1"/>
                <c:pt idx="0">
                  <c:v>A549-HA-M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overM A549'!$J$11:$P$11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16166321127132727</c:v>
                  </c:pt>
                  <c:pt idx="2">
                    <c:v>0.54581857740393802</c:v>
                  </c:pt>
                  <c:pt idx="3">
                    <c:v>0</c:v>
                  </c:pt>
                  <c:pt idx="4">
                    <c:v>0.71496400077743594</c:v>
                  </c:pt>
                  <c:pt idx="5">
                    <c:v>0</c:v>
                  </c:pt>
                  <c:pt idx="6">
                    <c:v>1.0858953649331788</c:v>
                  </c:pt>
                </c:numCache>
              </c:numRef>
            </c:plus>
            <c:minus>
              <c:numRef>
                <c:f>'overM A549'!$J$11:$P$11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16166321127132727</c:v>
                  </c:pt>
                  <c:pt idx="2">
                    <c:v>0.54581857740393802</c:v>
                  </c:pt>
                  <c:pt idx="3">
                    <c:v>0</c:v>
                  </c:pt>
                  <c:pt idx="4">
                    <c:v>0.71496400077743594</c:v>
                  </c:pt>
                  <c:pt idx="5">
                    <c:v>0</c:v>
                  </c:pt>
                  <c:pt idx="6">
                    <c:v>1.0858953649331788</c:v>
                  </c:pt>
                </c:numCache>
              </c:numRef>
            </c:minus>
          </c:errBars>
          <c:cat>
            <c:numRef>
              <c:f>'overM A549'!$J$4:$P$4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4">
                  <c:v>5</c:v>
                </c:pt>
                <c:pt idx="6">
                  <c:v>7</c:v>
                </c:pt>
              </c:numCache>
            </c:numRef>
          </c:cat>
          <c:val>
            <c:numRef>
              <c:f>'overM A549'!$J$7:$P$7</c:f>
              <c:numCache>
                <c:formatCode>General</c:formatCode>
                <c:ptCount val="7"/>
                <c:pt idx="0">
                  <c:v>1</c:v>
                </c:pt>
                <c:pt idx="1">
                  <c:v>2.0534393195719698</c:v>
                </c:pt>
                <c:pt idx="2">
                  <c:v>4.2333625739560334</c:v>
                </c:pt>
                <c:pt idx="4">
                  <c:v>16.051839743171968</c:v>
                </c:pt>
                <c:pt idx="6">
                  <c:v>31.55469863297836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1735552"/>
        <c:axId val="131737088"/>
      </c:lineChart>
      <c:catAx>
        <c:axId val="131735552"/>
        <c:scaling>
          <c:orientation val="minMax"/>
        </c:scaling>
        <c:delete val="0"/>
        <c:axPos val="b"/>
        <c:numFmt formatCode="General" sourceLinked="1"/>
        <c:majorTickMark val="none"/>
        <c:minorTickMark val="in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31737088"/>
        <c:crosses val="autoZero"/>
        <c:auto val="1"/>
        <c:lblAlgn val="ctr"/>
        <c:lblOffset val="100"/>
        <c:noMultiLvlLbl val="0"/>
      </c:catAx>
      <c:valAx>
        <c:axId val="13173708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3173555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0922200349956261"/>
          <c:y val="5.4979585885097708E-2"/>
          <c:w val="0.31281438125356698"/>
          <c:h val="0.2369892825896763"/>
        </c:manualLayout>
      </c:layout>
      <c:overlay val="0"/>
      <c:txPr>
        <a:bodyPr/>
        <a:lstStyle/>
        <a:p>
          <a:pPr>
            <a:defRPr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span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2849518810148728E-2"/>
          <c:y val="5.0925925925925923E-2"/>
          <c:w val="0.90120603674540689"/>
          <c:h val="0.83929753572470112"/>
        </c:manualLayout>
      </c:layout>
      <c:lineChart>
        <c:grouping val="standard"/>
        <c:varyColors val="0"/>
        <c:ser>
          <c:idx val="0"/>
          <c:order val="0"/>
          <c:tx>
            <c:strRef>
              <c:f>'overM H3255'!$H$4</c:f>
              <c:strCache>
                <c:ptCount val="1"/>
                <c:pt idx="0">
                  <c:v>H3255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overM H3255'!$I$8:$O$8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11942122994491541</c:v>
                  </c:pt>
                  <c:pt idx="2">
                    <c:v>0.34959932597643473</c:v>
                  </c:pt>
                  <c:pt idx="3">
                    <c:v>0</c:v>
                  </c:pt>
                  <c:pt idx="4">
                    <c:v>0.84305486558241582</c:v>
                  </c:pt>
                  <c:pt idx="5">
                    <c:v>0</c:v>
                  </c:pt>
                  <c:pt idx="6">
                    <c:v>0.8338991514930999</c:v>
                  </c:pt>
                </c:numCache>
              </c:numRef>
            </c:plus>
            <c:minus>
              <c:numRef>
                <c:f>'overM H3255'!$I$8:$O$8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11942122994491541</c:v>
                  </c:pt>
                  <c:pt idx="2">
                    <c:v>0.34959932597643473</c:v>
                  </c:pt>
                  <c:pt idx="3">
                    <c:v>0</c:v>
                  </c:pt>
                  <c:pt idx="4">
                    <c:v>0.84305486558241582</c:v>
                  </c:pt>
                  <c:pt idx="5">
                    <c:v>0</c:v>
                  </c:pt>
                  <c:pt idx="6">
                    <c:v>0.8338991514930999</c:v>
                  </c:pt>
                </c:numCache>
              </c:numRef>
            </c:minus>
          </c:errBars>
          <c:cat>
            <c:numRef>
              <c:f>'overM H3255'!$I$3:$O$3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4">
                  <c:v>5</c:v>
                </c:pt>
                <c:pt idx="6">
                  <c:v>7</c:v>
                </c:pt>
              </c:numCache>
            </c:numRef>
          </c:cat>
          <c:val>
            <c:numRef>
              <c:f>'overM H3255'!$I$4:$O$4</c:f>
              <c:numCache>
                <c:formatCode>General</c:formatCode>
                <c:ptCount val="7"/>
                <c:pt idx="0">
                  <c:v>1</c:v>
                </c:pt>
                <c:pt idx="1">
                  <c:v>1.4347470660107469</c:v>
                </c:pt>
                <c:pt idx="2">
                  <c:v>2.7951718355312436</c:v>
                </c:pt>
                <c:pt idx="4">
                  <c:v>9.2505344583884099</c:v>
                </c:pt>
                <c:pt idx="6">
                  <c:v>13.836093715300732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overM H3255'!$H$5</c:f>
              <c:strCache>
                <c:ptCount val="1"/>
                <c:pt idx="0">
                  <c:v>H3255-HA-C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overM H3255'!$I$9:$O$9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10453630561338791</c:v>
                  </c:pt>
                  <c:pt idx="2">
                    <c:v>0.39188733417986876</c:v>
                  </c:pt>
                  <c:pt idx="3">
                    <c:v>0</c:v>
                  </c:pt>
                  <c:pt idx="4">
                    <c:v>0.79803989773095363</c:v>
                  </c:pt>
                  <c:pt idx="5">
                    <c:v>0</c:v>
                  </c:pt>
                  <c:pt idx="6">
                    <c:v>0.51558681664483952</c:v>
                  </c:pt>
                </c:numCache>
              </c:numRef>
            </c:plus>
            <c:minus>
              <c:numRef>
                <c:f>'overM H3255'!$I$9:$O$9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10453630561338791</c:v>
                  </c:pt>
                  <c:pt idx="2">
                    <c:v>0.39188733417986876</c:v>
                  </c:pt>
                  <c:pt idx="3">
                    <c:v>0</c:v>
                  </c:pt>
                  <c:pt idx="4">
                    <c:v>0.79803989773095363</c:v>
                  </c:pt>
                  <c:pt idx="5">
                    <c:v>0</c:v>
                  </c:pt>
                  <c:pt idx="6">
                    <c:v>0.51558681664483952</c:v>
                  </c:pt>
                </c:numCache>
              </c:numRef>
            </c:minus>
          </c:errBars>
          <c:cat>
            <c:numRef>
              <c:f>'overM H3255'!$I$3:$O$3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4">
                  <c:v>5</c:v>
                </c:pt>
                <c:pt idx="6">
                  <c:v>7</c:v>
                </c:pt>
              </c:numCache>
            </c:numRef>
          </c:cat>
          <c:val>
            <c:numRef>
              <c:f>'overM H3255'!$I$5:$O$5</c:f>
              <c:numCache>
                <c:formatCode>General</c:formatCode>
                <c:ptCount val="7"/>
                <c:pt idx="0">
                  <c:v>1</c:v>
                </c:pt>
                <c:pt idx="1">
                  <c:v>1.3555210418759334</c:v>
                </c:pt>
                <c:pt idx="2">
                  <c:v>2.5665821154617898</c:v>
                </c:pt>
                <c:pt idx="4">
                  <c:v>9.135384512802581</c:v>
                </c:pt>
                <c:pt idx="6">
                  <c:v>13.148343769043066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overM H3255'!$H$6</c:f>
              <c:strCache>
                <c:ptCount val="1"/>
                <c:pt idx="0">
                  <c:v>H3255-HA-M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overM H3255'!$I$10:$O$10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8.4092060116269587E-2</c:v>
                  </c:pt>
                  <c:pt idx="2">
                    <c:v>0.26174284323859787</c:v>
                  </c:pt>
                  <c:pt idx="3">
                    <c:v>0</c:v>
                  </c:pt>
                  <c:pt idx="4">
                    <c:v>0.71496400077743516</c:v>
                  </c:pt>
                  <c:pt idx="5">
                    <c:v>0</c:v>
                  </c:pt>
                  <c:pt idx="6">
                    <c:v>0.91898242997084656</c:v>
                  </c:pt>
                </c:numCache>
              </c:numRef>
            </c:plus>
            <c:minus>
              <c:numRef>
                <c:f>'overM H3255'!$I$10:$O$10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8.4092060116269587E-2</c:v>
                  </c:pt>
                  <c:pt idx="2">
                    <c:v>0.26174284323859787</c:v>
                  </c:pt>
                  <c:pt idx="3">
                    <c:v>0</c:v>
                  </c:pt>
                  <c:pt idx="4">
                    <c:v>0.71496400077743516</c:v>
                  </c:pt>
                  <c:pt idx="5">
                    <c:v>0</c:v>
                  </c:pt>
                  <c:pt idx="6">
                    <c:v>0.91898242997084656</c:v>
                  </c:pt>
                </c:numCache>
              </c:numRef>
            </c:minus>
          </c:errBars>
          <c:cat>
            <c:numRef>
              <c:f>'overM H3255'!$I$3:$O$3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4">
                  <c:v>5</c:v>
                </c:pt>
                <c:pt idx="6">
                  <c:v>7</c:v>
                </c:pt>
              </c:numCache>
            </c:numRef>
          </c:cat>
          <c:val>
            <c:numRef>
              <c:f>'overM H3255'!$I$6:$O$6</c:f>
              <c:numCache>
                <c:formatCode>General</c:formatCode>
                <c:ptCount val="7"/>
                <c:pt idx="0">
                  <c:v>1</c:v>
                </c:pt>
                <c:pt idx="1">
                  <c:v>1.9409673590515564</c:v>
                </c:pt>
                <c:pt idx="2">
                  <c:v>4.2666959072893667</c:v>
                </c:pt>
                <c:pt idx="4">
                  <c:v>14.051839743171966</c:v>
                </c:pt>
                <c:pt idx="6">
                  <c:v>20.63289513365133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1768320"/>
        <c:axId val="131769856"/>
      </c:lineChart>
      <c:catAx>
        <c:axId val="131768320"/>
        <c:scaling>
          <c:orientation val="minMax"/>
        </c:scaling>
        <c:delete val="0"/>
        <c:axPos val="b"/>
        <c:numFmt formatCode="General" sourceLinked="1"/>
        <c:majorTickMark val="none"/>
        <c:minorTickMark val="in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31769856"/>
        <c:crosses val="autoZero"/>
        <c:auto val="1"/>
        <c:lblAlgn val="ctr"/>
        <c:lblOffset val="100"/>
        <c:noMultiLvlLbl val="0"/>
      </c:catAx>
      <c:valAx>
        <c:axId val="13176985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3176832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7.145569684176506E-2"/>
          <c:y val="5.4979585885097694E-2"/>
          <c:w val="0.33517689953641516"/>
          <c:h val="0.2369892825896763"/>
        </c:manualLayout>
      </c:layout>
      <c:overlay val="0"/>
      <c:txPr>
        <a:bodyPr/>
        <a:lstStyle/>
        <a:p>
          <a:pPr>
            <a:defRPr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span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9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9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9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4407325" y="849623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72008" y="845066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-665634" y="2320218"/>
            <a:ext cx="19324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old change of cell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mber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 rot="16200000">
            <a:off x="3856253" y="2332252"/>
            <a:ext cx="19472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old change of cell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mber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" name="组合 16"/>
          <p:cNvGrpSpPr/>
          <p:nvPr/>
        </p:nvGrpSpPr>
        <p:grpSpPr>
          <a:xfrm>
            <a:off x="423719" y="1228253"/>
            <a:ext cx="3761953" cy="2743200"/>
            <a:chOff x="4572000" y="692696"/>
            <a:chExt cx="3761953" cy="2743200"/>
          </a:xfrm>
        </p:grpSpPr>
        <p:graphicFrame>
          <p:nvGraphicFramePr>
            <p:cNvPr id="24" name="图表 3"/>
            <p:cNvGraphicFramePr>
              <a:graphicFrameLocks/>
            </p:cNvGraphicFramePr>
            <p:nvPr/>
          </p:nvGraphicFramePr>
          <p:xfrm>
            <a:off x="4572000" y="692696"/>
            <a:ext cx="3761953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5" name="TextBox 7"/>
            <p:cNvSpPr txBox="1"/>
            <p:nvPr/>
          </p:nvSpPr>
          <p:spPr>
            <a:xfrm>
              <a:off x="7860745" y="823060"/>
              <a:ext cx="2306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zh-CN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TextBox 11"/>
            <p:cNvSpPr txBox="1"/>
            <p:nvPr/>
          </p:nvSpPr>
          <p:spPr>
            <a:xfrm>
              <a:off x="6893366" y="1847964"/>
              <a:ext cx="2306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zh-CN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TextBox 13"/>
            <p:cNvSpPr txBox="1"/>
            <p:nvPr/>
          </p:nvSpPr>
          <p:spPr>
            <a:xfrm>
              <a:off x="4644008" y="3140024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dirty="0" smtClean="0">
                  <a:latin typeface="Arial" pitchFamily="34" charset="0"/>
                  <a:cs typeface="Arial" pitchFamily="34" charset="0"/>
                </a:rPr>
                <a:t>Day</a:t>
              </a:r>
              <a:endParaRPr lang="zh-CN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8" name="组合 17"/>
          <p:cNvGrpSpPr/>
          <p:nvPr/>
        </p:nvGrpSpPr>
        <p:grpSpPr>
          <a:xfrm>
            <a:off x="4954960" y="1178602"/>
            <a:ext cx="3960440" cy="2743200"/>
            <a:chOff x="467544" y="3717032"/>
            <a:chExt cx="3960440" cy="2743200"/>
          </a:xfrm>
        </p:grpSpPr>
        <p:graphicFrame>
          <p:nvGraphicFramePr>
            <p:cNvPr id="29" name="图表 4"/>
            <p:cNvGraphicFramePr>
              <a:graphicFrameLocks/>
            </p:cNvGraphicFramePr>
            <p:nvPr/>
          </p:nvGraphicFramePr>
          <p:xfrm>
            <a:off x="467544" y="3717032"/>
            <a:ext cx="396044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30" name="TextBox 8"/>
            <p:cNvSpPr txBox="1"/>
            <p:nvPr/>
          </p:nvSpPr>
          <p:spPr>
            <a:xfrm>
              <a:off x="3948870" y="4015517"/>
              <a:ext cx="2306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zh-CN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TextBox 9"/>
            <p:cNvSpPr txBox="1"/>
            <p:nvPr/>
          </p:nvSpPr>
          <p:spPr>
            <a:xfrm>
              <a:off x="2937512" y="4627683"/>
              <a:ext cx="2306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zh-CN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TextBox 14"/>
            <p:cNvSpPr txBox="1"/>
            <p:nvPr/>
          </p:nvSpPr>
          <p:spPr>
            <a:xfrm>
              <a:off x="539552" y="6177876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dirty="0" smtClean="0">
                  <a:latin typeface="Arial" pitchFamily="34" charset="0"/>
                  <a:cs typeface="Arial" pitchFamily="34" charset="0"/>
                </a:rPr>
                <a:t>Day</a:t>
              </a:r>
              <a:endParaRPr lang="zh-CN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999783" y="4724400"/>
            <a:ext cx="700121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 MAP4K4 overexpression promotes proliferation of lung adenocarcinoma cells. pcDNA3.1-HA-MAP4K4 or pcDNA3.1-HA was transiently transfected into A549 (A) or H3255 (B) cell lines followed by G418 selection. The established MAP4K4 overexpression cell lines (HA-M), control cell lines (HA-C) and parental cells were used for MTT assay. * denotes a statistically significant difference (p&lt;0.05) compared with parental cell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55610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92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o, Chenxi</dc:creator>
  <cp:lastModifiedBy>Gao, Chenxi</cp:lastModifiedBy>
  <cp:revision>5</cp:revision>
  <dcterms:created xsi:type="dcterms:W3CDTF">2006-08-16T00:00:00Z</dcterms:created>
  <dcterms:modified xsi:type="dcterms:W3CDTF">2016-12-29T15:06:31Z</dcterms:modified>
</cp:coreProperties>
</file>